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941CA"/>
    <a:srgbClr val="7C39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44"/>
    <p:restoredTop sz="94675"/>
  </p:normalViewPr>
  <p:slideViewPr>
    <p:cSldViewPr snapToGrid="0" snapToObjects="1">
      <p:cViewPr varScale="1">
        <p:scale>
          <a:sx n="119" d="100"/>
          <a:sy n="119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lvatoreesposito/GoogleDrive/arbor/writing/material/Supplementary%20Fig%20XX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3449084017833"/>
          <c:y val="6.2885048428593798E-2"/>
          <c:w val="0.48329818364919391"/>
          <c:h val="0.91167611915643398"/>
        </c:manualLayout>
      </c:layout>
      <c:pieChart>
        <c:varyColors val="1"/>
        <c:ser>
          <c:idx val="0"/>
          <c:order val="0"/>
          <c:explosion val="11"/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4AF2-2F4B-946B-6DF7B7E9073C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2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4AF2-2F4B-946B-6DF7B7E9073C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4AF2-2F4B-946B-6DF7B7E9073C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4AF2-2F4B-946B-6DF7B7E9073C}"/>
              </c:ext>
            </c:extLst>
          </c:dPt>
          <c:dPt>
            <c:idx val="4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4AF2-2F4B-946B-6DF7B7E9073C}"/>
              </c:ext>
            </c:extLst>
          </c:dPt>
          <c:dPt>
            <c:idx val="5"/>
            <c:bubble3D val="0"/>
            <c:spPr>
              <a:gradFill rotWithShape="1">
                <a:gsLst>
                  <a:gs pos="0">
                    <a:schemeClr val="accent6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4AF2-2F4B-946B-6DF7B7E9073C}"/>
              </c:ext>
            </c:extLst>
          </c:dPt>
          <c:dPt>
            <c:idx val="6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4AF2-2F4B-946B-6DF7B7E9073C}"/>
              </c:ext>
            </c:extLst>
          </c:dPt>
          <c:dPt>
            <c:idx val="7"/>
            <c:bubble3D val="0"/>
            <c:spPr>
              <a:gradFill rotWithShape="1">
                <a:gsLst>
                  <a:gs pos="0">
                    <a:schemeClr val="accent2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4AF2-2F4B-946B-6DF7B7E9073C}"/>
              </c:ext>
            </c:extLst>
          </c:dPt>
          <c:dLbls>
            <c:dLbl>
              <c:idx val="0"/>
              <c:layout>
                <c:manualLayout>
                  <c:x val="3.0988977538493494E-2"/>
                  <c:y val="0.11287600301388104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4AF2-2F4B-946B-6DF7B7E9073C}"/>
                </c:ext>
              </c:extLst>
            </c:dLbl>
            <c:dLbl>
              <c:idx val="1"/>
              <c:layout>
                <c:manualLayout>
                  <c:x val="-5.9728959353155246E-2"/>
                  <c:y val="-3.4163275719494629E-3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AF2-2F4B-946B-6DF7B7E9073C}"/>
                </c:ext>
              </c:extLst>
            </c:dLbl>
            <c:dLbl>
              <c:idx val="2"/>
              <c:layout>
                <c:manualLayout>
                  <c:x val="-2.2381127403074946E-2"/>
                  <c:y val="-7.5665689504724826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4AF2-2F4B-946B-6DF7B7E9073C}"/>
                </c:ext>
              </c:extLst>
            </c:dLbl>
            <c:dLbl>
              <c:idx val="3"/>
              <c:layout>
                <c:manualLayout>
                  <c:x val="-1.1026220241516657E-2"/>
                  <c:y val="-4.7693378296680661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4AF2-2F4B-946B-6DF7B7E9073C}"/>
                </c:ext>
              </c:extLst>
            </c:dLbl>
            <c:dLbl>
              <c:idx val="4"/>
              <c:layout>
                <c:manualLayout>
                  <c:x val="-8.4976902862490804E-3"/>
                  <c:y val="-3.3581545040944509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4AF2-2F4B-946B-6DF7B7E9073C}"/>
                </c:ext>
              </c:extLst>
            </c:dLbl>
            <c:dLbl>
              <c:idx val="5"/>
              <c:layout>
                <c:manualLayout>
                  <c:x val="-1.1501035213448758E-2"/>
                  <c:y val="-1.7791230161842239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4AF2-2F4B-946B-6DF7B7E9073C}"/>
                </c:ext>
              </c:extLst>
            </c:dLbl>
            <c:dLbl>
              <c:idx val="6"/>
              <c:layout>
                <c:manualLayout>
                  <c:x val="-4.8750214826162553E-3"/>
                  <c:y val="-2.6496343336255224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4AF2-2F4B-946B-6DF7B7E9073C}"/>
                </c:ext>
              </c:extLst>
            </c:dLbl>
            <c:dLbl>
              <c:idx val="7"/>
              <c:layout>
                <c:manualLayout>
                  <c:x val="2.6620170921824556E-2"/>
                  <c:y val="-3.2112526170435175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4AF2-2F4B-946B-6DF7B7E9073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overflow" horzOverflow="overflow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it-IT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eparator>, </c:separator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rec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Foglio1!$B$2:$B$9</c:f>
              <c:strCache>
                <c:ptCount val="8"/>
                <c:pt idx="0">
                  <c:v>intergenic_region</c:v>
                </c:pt>
                <c:pt idx="1">
                  <c:v>upstream_gene_variant</c:v>
                </c:pt>
                <c:pt idx="2">
                  <c:v>missense_variant</c:v>
                </c:pt>
                <c:pt idx="3">
                  <c:v>intron_variant</c:v>
                </c:pt>
                <c:pt idx="4">
                  <c:v>synonymous_variant</c:v>
                </c:pt>
                <c:pt idx="5">
                  <c:v>downstream_gene_variant</c:v>
                </c:pt>
                <c:pt idx="6">
                  <c:v>3_prime_UTR_variant</c:v>
                </c:pt>
                <c:pt idx="7">
                  <c:v>5_prime_UTR_variant</c:v>
                </c:pt>
              </c:strCache>
            </c:strRef>
          </c:cat>
          <c:val>
            <c:numRef>
              <c:f>Foglio1!$C$2:$C$9</c:f>
              <c:numCache>
                <c:formatCode>General</c:formatCode>
                <c:ptCount val="8"/>
                <c:pt idx="0">
                  <c:v>6777476</c:v>
                </c:pt>
                <c:pt idx="1">
                  <c:v>2536218</c:v>
                </c:pt>
                <c:pt idx="2">
                  <c:v>1635941</c:v>
                </c:pt>
                <c:pt idx="3">
                  <c:v>1098958</c:v>
                </c:pt>
                <c:pt idx="4">
                  <c:v>994634</c:v>
                </c:pt>
                <c:pt idx="5">
                  <c:v>649120</c:v>
                </c:pt>
                <c:pt idx="6">
                  <c:v>452500</c:v>
                </c:pt>
                <c:pt idx="7">
                  <c:v>2582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AF2-2F4B-946B-6DF7B7E9073C}"/>
            </c:ext>
          </c:extLst>
        </c:ser>
        <c:ser>
          <c:idx val="1"/>
          <c:order val="1"/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2-4AF2-2F4B-946B-6DF7B7E9073C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2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4-4AF2-2F4B-946B-6DF7B7E9073C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6-4AF2-2F4B-946B-6DF7B7E9073C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8-4AF2-2F4B-946B-6DF7B7E9073C}"/>
              </c:ext>
            </c:extLst>
          </c:dPt>
          <c:dPt>
            <c:idx val="4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A-4AF2-2F4B-946B-6DF7B7E9073C}"/>
              </c:ext>
            </c:extLst>
          </c:dPt>
          <c:dPt>
            <c:idx val="5"/>
            <c:bubble3D val="0"/>
            <c:spPr>
              <a:gradFill rotWithShape="1">
                <a:gsLst>
                  <a:gs pos="0">
                    <a:schemeClr val="accent6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C-4AF2-2F4B-946B-6DF7B7E9073C}"/>
              </c:ext>
            </c:extLst>
          </c:dPt>
          <c:dPt>
            <c:idx val="6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E-4AF2-2F4B-946B-6DF7B7E9073C}"/>
              </c:ext>
            </c:extLst>
          </c:dPt>
          <c:dPt>
            <c:idx val="7"/>
            <c:bubble3D val="0"/>
            <c:spPr>
              <a:gradFill rotWithShape="1">
                <a:gsLst>
                  <a:gs pos="0">
                    <a:schemeClr val="accent2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0-4AF2-2F4B-946B-6DF7B7E9073C}"/>
              </c:ext>
            </c:extLst>
          </c:dPt>
          <c:cat>
            <c:strRef>
              <c:f>Foglio1!$B$2:$B$9</c:f>
              <c:strCache>
                <c:ptCount val="8"/>
                <c:pt idx="0">
                  <c:v>intergenic_region</c:v>
                </c:pt>
                <c:pt idx="1">
                  <c:v>upstream_gene_variant</c:v>
                </c:pt>
                <c:pt idx="2">
                  <c:v>missense_variant</c:v>
                </c:pt>
                <c:pt idx="3">
                  <c:v>intron_variant</c:v>
                </c:pt>
                <c:pt idx="4">
                  <c:v>synonymous_variant</c:v>
                </c:pt>
                <c:pt idx="5">
                  <c:v>downstream_gene_variant</c:v>
                </c:pt>
                <c:pt idx="6">
                  <c:v>3_prime_UTR_variant</c:v>
                </c:pt>
                <c:pt idx="7">
                  <c:v>5_prime_UTR_variant</c:v>
                </c:pt>
              </c:strCache>
            </c:strRef>
          </c:cat>
          <c:val>
            <c:numRef>
              <c:f>Foglio1!$D$2:$D$9</c:f>
              <c:numCache>
                <c:formatCode>General</c:formatCode>
                <c:ptCount val="8"/>
                <c:pt idx="0">
                  <c:v>45.043640147792843</c:v>
                </c:pt>
                <c:pt idx="1">
                  <c:v>16.855904901523054</c:v>
                </c:pt>
                <c:pt idx="2">
                  <c:v>10.872592939764061</c:v>
                </c:pt>
                <c:pt idx="3">
                  <c:v>7.3037615610203748</c:v>
                </c:pt>
                <c:pt idx="4">
                  <c:v>6.610416027258494</c:v>
                </c:pt>
                <c:pt idx="5">
                  <c:v>4.3141027268462908</c:v>
                </c:pt>
                <c:pt idx="6">
                  <c:v>3.0073506961701173</c:v>
                </c:pt>
                <c:pt idx="7">
                  <c:v>1.71630999598178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4AF2-2F4B-946B-6DF7B7E907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0121475376353462"/>
          <c:y val="1.462625789332095E-2"/>
          <c:w val="0.39627301452934693"/>
          <c:h val="0.413428225317989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412AA7-0697-504E-9E5B-5CDBF4844D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1BB9E11-78B6-B14F-A088-BDBDDE32C9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201F934-6BC5-D14D-8F2C-283CCED2A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6B76D8-B9F9-C540-939A-AA4E337D3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348F7F-8911-EB42-911F-7B1445B4D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9444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C7E22A-1369-8242-9A22-646A16DB4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D2742AF-C824-2C40-BCAE-4E482391B1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D30D05B-077D-F945-B86D-745A7CDA0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9F16388-9BEB-5E49-8AA9-45C4FD7D0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C3C4494-7959-5F41-83D7-5402170F3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3260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CA39C11-B8B3-224D-8666-72C06B2FF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D067107-3921-6C42-BF8C-AEB8D4147F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893A2B-EAFC-D648-8194-DFA393642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2A6AFB1-DE64-5142-B16C-DDE05F303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E7FABC-0E44-A84C-8A30-899DE1140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3269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E0CCB9-9CAF-C24A-BF6B-D4175CDE5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CB3FB7C-6352-2344-95C8-A7A443164C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C5C8D36-541E-1F4A-91A1-2B5B038BC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C296AD-45D4-8F44-9BD8-72170153F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7D51C3C-FD63-3B40-AD9E-B5B500120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746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5EEED0-58E9-B940-9F2B-673A790762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39A8BCB-2E2C-2444-81DA-CCC1515BE8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6CFDCAB-2295-E14A-9151-392DD7832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D284AB-FAAC-1A4D-844A-6856331AB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B92235E-E2AF-9A42-ADB3-E3FF29BFC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7347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CE016F-CAAD-3042-96FB-6C049EAF8C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267D05E-A917-F245-9B2F-23ADD590DD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5D2A5B3-F923-0B42-B544-BC604B52AC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A28AB4F-17C2-1044-9DD7-0A3677A31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85CCD9E-1654-6342-B090-98F137FDED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AE92003-9136-2A40-BC8B-29F85BA0E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7182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A48074-8C44-2949-B944-0FF7C5C53D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FF2B811-5E61-6D45-B18B-81BFCFF5F9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F02A62D-D727-3B4E-B8BC-53546F74DF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ADBB5C5-55FD-6145-938F-D93EDED15B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3C1E5A0-8F11-4145-9977-3EE9549EED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D7E9DF7-D9A2-8546-9FED-E829F41BF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9698CF3-3677-F34A-BF7C-A0FA7CEBF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F9CADCE-54A2-C449-8F99-382C0DD03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447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794D233-E245-6B45-B21B-2DCF1064B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8D73D9C-2CEC-304A-98B8-6F0F8C495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049A8CF-CEB1-7746-8B94-31CB04EE4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AAA55E9-F1CC-444F-A787-6B10FF335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669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C977697-2D31-9141-BB1E-6F357C72E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76337A6-A440-5A46-A0D7-187F5B892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3ECD055-C9CD-ED4F-A08E-BD19F207E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0098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86A9AF-8E8C-024B-B14D-D138FC369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F4C0882-8678-E943-BBEE-C71E6AC925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6F56604-5D09-F545-BE1C-09FCE2E50B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108EFE5-487B-D24B-ADA5-E85C627E2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A86966B-138C-9A47-8E0D-E73D79C33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B7D4435-E297-1E47-A2A1-24074DCC9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1367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FEBCF0F-F19B-0B44-B399-762C9E4FC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B263DF1-10E1-1A4E-BFF6-F6E069F245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960211-7CB6-FE4C-8F21-959F763948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AD788B8-74F4-5B4D-85B2-C947CBA58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07B974D-0297-7848-969D-1387FA720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993CF32-5B9C-C14C-A899-4826AF8FB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5759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E5BB7B8-0540-5949-99F8-0182094E7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937DAE6-FE65-2344-9972-0A4E0BCFA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91DFD2E-92C5-0040-B25C-2A217E5273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30D69-CC14-4441-B0C0-BC3BDAEA79BD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D82CF1-8D44-A34E-9AE2-5B464AD81D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19C1EE-6515-874E-AA90-68F5BEA850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FA755-F8CD-8444-BBDA-461ED67028E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6147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9DF4AF63-4186-BC4F-B778-ABE917FBA7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3778348"/>
              </p:ext>
            </p:extLst>
          </p:nvPr>
        </p:nvGraphicFramePr>
        <p:xfrm>
          <a:off x="1948722" y="910652"/>
          <a:ext cx="8646526" cy="50366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1A3802C4-2F73-E322-73B5-6B8E74C3E596}"/>
              </a:ext>
            </a:extLst>
          </p:cNvPr>
          <p:cNvSpPr txBox="1"/>
          <p:nvPr/>
        </p:nvSpPr>
        <p:spPr>
          <a:xfrm>
            <a:off x="0" y="6041332"/>
            <a:ext cx="104815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equence changes grouped by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pEff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tegories. Only categories with a number of variations greater than 1% are given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04671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3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9</cp:revision>
  <dcterms:created xsi:type="dcterms:W3CDTF">2022-02-21T09:50:34Z</dcterms:created>
  <dcterms:modified xsi:type="dcterms:W3CDTF">2022-11-04T13:44:18Z</dcterms:modified>
</cp:coreProperties>
</file>